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8" d="100"/>
          <a:sy n="108" d="100"/>
        </p:scale>
        <p:origin x="-180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19/3/19 Tues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18038" y="5085184"/>
            <a:ext cx="8280920" cy="132343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. </a:t>
            </a:r>
            <a:r>
              <a:rPr lang="en-US" altLang="zh-CN" sz="1600" b="1" dirty="0" smtClean="0">
                <a:latin typeface="Times New Roman" pitchFamily="18" charset="0"/>
                <a:cs typeface="Times New Roman" pitchFamily="18" charset="0"/>
              </a:rPr>
              <a:t>S3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principal component analysis (PCA) in the hybrid and its parents. T, H and F represent T449, H1 and F</a:t>
            </a:r>
            <a:r>
              <a:rPr lang="en-US" altLang="zh-CN" sz="1600" baseline="-25000" dirty="0">
                <a:latin typeface="Times New Roman" pitchFamily="18" charset="0"/>
                <a:cs typeface="Times New Roman" pitchFamily="18" charset="0"/>
              </a:rPr>
              <a:t>1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, respectively.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L1 and P1 represent flag leaves and anthers at meiosis stage, respectively. L2, P2, E2 and Z2 represent flag leaves, anther, embryo sac and leaf sheath at pre-flowering stage, respectively. L3, P3 and Z3 represent flag leaves, grain and leaf sheath at three days after flowering, respectively. 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4" name="Picture 2" descr="D:\论文\投稿论文\第二篇\第一次审稿意见回复\Figure\附图\PCA.png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221359"/>
            <a:ext cx="8613956" cy="475252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2807292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90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cp:lastModifiedBy>微软用户</cp:lastModifiedBy>
  <cp:revision>12</cp:revision>
  <dcterms:modified xsi:type="dcterms:W3CDTF">2019-03-19T06:45:33Z</dcterms:modified>
</cp:coreProperties>
</file>